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72" r:id="rId3"/>
    <p:sldId id="274" r:id="rId4"/>
    <p:sldId id="275" r:id="rId5"/>
    <p:sldId id="280" r:id="rId6"/>
    <p:sldId id="281" r:id="rId7"/>
    <p:sldId id="282" r:id="rId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01" autoAdjust="0"/>
    <p:restoredTop sz="94660"/>
  </p:normalViewPr>
  <p:slideViewPr>
    <p:cSldViewPr snapToGrid="0">
      <p:cViewPr varScale="1">
        <p:scale>
          <a:sx n="84" d="100"/>
          <a:sy n="84" d="100"/>
        </p:scale>
        <p:origin x="132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A5B42A-6B97-4B2A-91BC-96E93785F2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0ECBDAA-FD7B-4962-9345-5960D23017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B4CFB5C-2639-4D7D-A1A9-B974245D4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C85C426-A23C-487F-A2FD-C4965B5C4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88A044F-ED2D-4325-8D49-B5D221FC3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9815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E09F39-CCE3-4F32-92C6-35B13C75B2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126504E-8203-4901-BB9B-4A433EA0F4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18B4006-9242-449B-895C-6BA1A8C2C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BBE97BA-8C2A-405F-824D-1E38D55B3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11842D3-C37B-4E70-AAAE-5CB07CD23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7136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98F9470-8BB3-4355-8843-7B5F8140AC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8C69B27-6E80-4672-8B99-20D9BF2A8E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204E36A-D961-4AB5-A622-F32E8EFD7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5D9E9E1-D85E-413E-A94D-408F85F8B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EE776B8-EF3F-4B31-B7F7-2D2FAFDEB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9174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FD12571-1211-49A9-9E74-03C8FCA04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B84DFF2-4FF7-4368-A621-7B411C91B5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0E4295B-A406-43F5-83E0-CA562CD63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75AF4A0-18CE-4039-95CE-D6355EC36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3A50640-FB80-4924-827E-5057F83D8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9020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D8D05C-5364-4141-8273-5009C7E9E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5FB3FA2-4BB2-4AA8-89F6-496C9E06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4522525-2FBF-4BF8-83E3-3970136BF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ACB9468-1C4E-4A17-8860-881CC3370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8739044-FA9D-48BA-BED7-627173594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1778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82FE24B-C7B0-4530-9081-B431933F9E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33686D8-F5A3-4A88-A963-97E9FDA29D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2D0BC6D-C723-4BFC-B21C-7B51A613C1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050A87F-6B88-4EDD-A7D4-4CDDE0C27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2356037-349B-4FAA-8D34-09BC3523D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0713514-0A4C-44FD-8481-2D2F442D3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5304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D6BE188-ECD6-4C60-A626-FD50130C7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FBDCEFF-CBDA-49C8-AF7C-398842AF68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913BA49-CB74-4D5A-80E1-968D6799D2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EA08F14-0614-4D3E-A773-C27A51EC12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ACB4884E-AC92-4BD6-B4E2-F90159AFC9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6ADDDA5-F1F4-4159-AE3C-2106D5E47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4B7F2F5-F0D5-48D5-A108-AB577C3D1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E5DCA5E-7F54-4DC8-B187-3304F5C53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5839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4072DBF-C881-4643-9790-607DF5DEE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1CD6941-76A9-4901-AAF5-21E711E30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363B71A-9DAD-4E80-A315-C8984A00B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44EDF3C-E03B-4A69-B0CD-C6E646717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4834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2216552-208B-4252-8883-40BE62EBE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2C4895E6-B928-4065-AC4B-58C587606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F0B8635-BC34-4ED7-8B3A-723072889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1146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A9083B-A15A-4178-9429-CBE5A70B8B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C710D00-56D3-460C-A255-934444989B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3EB470B-6CA2-4C22-B5FC-F49E4F734D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07C0E9D-A5A0-46F1-9004-6D2042AA4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AE6858D-F28C-43F3-8D5A-37BAB16CF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510922B-957C-4B13-BEBB-632C7C64E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0997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57DA18E-8874-45A6-91E2-6E3B03A121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DB3FAAE-5B1F-4F14-A13F-E1C8035BC6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0C56563-3C8A-4745-B4F6-537F96BDF4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1882F8C-4660-417D-9BA1-360630AAC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D1FBF98-B075-4645-A45A-44D81A09B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078D2D9-00FB-40D6-8DE6-C356CE8D1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6687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188DAB7-4815-4A62-A418-C71D991218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3C54390-19FD-4132-AC65-FD0900B461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9BC3A27-AC05-496B-9687-AF5FB9482F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AD72117-3F1F-406F-91A4-B43049DEFC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8CD4A75-DA79-472F-8537-5F0D153DEF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5353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emf"/><Relationship Id="rId4" Type="http://schemas.openxmlformats.org/officeDocument/2006/relationships/package" Target="../embeddings/Microsoft_Excel_Worksheet1.xlsx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package" Target="../embeddings/Microsoft_Excel_Worksheet2.xlsx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package" Target="../embeddings/Microsoft_Excel_Worksheet3.xlsx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package" Target="../embeddings/Microsoft_Excel_Worksheet4.xlsx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emf"/><Relationship Id="rId4" Type="http://schemas.openxmlformats.org/officeDocument/2006/relationships/package" Target="../embeddings/Microsoft_Excel_Worksheet5.xlsx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package" Target="../embeddings/Microsoft_Excel_Worksheet6.xlsx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package" Target="../embeddings/Microsoft_Excel_Worksheet7.xlsx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package" Target="../embeddings/Microsoft_Excel_Worksheet8.xlsx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emf"/><Relationship Id="rId4" Type="http://schemas.openxmlformats.org/officeDocument/2006/relationships/package" Target="../embeddings/Microsoft_Excel_Worksheet9.xlsx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package" Target="../embeddings/Microsoft_Excel_Worksheet10.xlsx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emf"/><Relationship Id="rId4" Type="http://schemas.openxmlformats.org/officeDocument/2006/relationships/package" Target="../embeddings/Microsoft_Excel_Worksheet11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E53618-2A14-4B80-BA28-09EAC167D87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olved HBV infection is not associated with liver-related outcomes after </a:t>
            </a:r>
            <a:r>
              <a:rPr lang="en-GB" sz="1800" b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CV cure – </a:t>
            </a: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from the German Hepatitis C-Registry</a:t>
            </a:r>
            <a:b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9E2C4E1-9F78-4A67-999F-42D03F4B7E9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Tables</a:t>
            </a:r>
            <a:r>
              <a:rPr lang="de-DE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8780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1CCD5C-4BD7-432C-85EC-6A097DD52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73079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Table 1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6E5F2300-2BFF-4A03-8D89-98E7A9670304}"/>
              </a:ext>
            </a:extLst>
          </p:cNvPr>
          <p:cNvSpPr txBox="1"/>
          <p:nvPr/>
        </p:nvSpPr>
        <p:spPr>
          <a:xfrm>
            <a:off x="0" y="1074509"/>
            <a:ext cx="2087479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1a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vent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clud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Univariate Analysis Overall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hor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bbrevi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MI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CV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C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T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otyp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Bc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r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HBs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rfa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defini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bas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on 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osit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/total score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corporat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resen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f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-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lic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e.g.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ascite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)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nfirma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rough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histolog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ultrasoun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live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stiffne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measuremen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LSM) vi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FibroSca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® (&gt;12.5 kPa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AST/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latele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rati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APRI &gt;2.0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FIB-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&gt;3.25).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5D078CAE-8078-4C97-B14A-518EE3F85FF6}"/>
              </a:ext>
            </a:extLst>
          </p:cNvPr>
          <p:cNvSpPr txBox="1"/>
          <p:nvPr/>
        </p:nvSpPr>
        <p:spPr>
          <a:xfrm>
            <a:off x="7668858" y="1052484"/>
            <a:ext cx="417495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1b: </a:t>
            </a:r>
            <a:b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clu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– Multivariate Analysis Overall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hort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AB0BB688-BAC8-5888-8034-3C74F052E1A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15905" y="875082"/>
          <a:ext cx="5334000" cy="572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5334080" imgH="5724353" progId="Excel.Sheet.12">
                  <p:embed/>
                </p:oleObj>
              </mc:Choice>
              <mc:Fallback>
                <p:oleObj name="Worksheet" r:id="rId2" imgW="5334080" imgH="5724353" progId="Excel.Sheet.12">
                  <p:embed/>
                  <p:pic>
                    <p:nvPicPr>
                      <p:cNvPr id="4" name="Objekt 3">
                        <a:extLst>
                          <a:ext uri="{FF2B5EF4-FFF2-40B4-BE49-F238E27FC236}">
                            <a16:creationId xmlns:a16="http://schemas.microsoft.com/office/drawing/2014/main" id="{AB0BB688-BAC8-5888-8034-3C74F052E1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15905" y="875082"/>
                        <a:ext cx="5334000" cy="5724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A3478F6C-382D-E03C-CFA4-92ED2084230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748868" y="1704975"/>
          <a:ext cx="3590925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4" imgW="3591065" imgH="1723889" progId="Excel.Sheet.12">
                  <p:embed/>
                </p:oleObj>
              </mc:Choice>
              <mc:Fallback>
                <p:oleObj name="Worksheet" r:id="rId4" imgW="3591065" imgH="1723889" progId="Excel.Sheet.12">
                  <p:embed/>
                  <p:pic>
                    <p:nvPicPr>
                      <p:cNvPr id="7" name="Objekt 6">
                        <a:extLst>
                          <a:ext uri="{FF2B5EF4-FFF2-40B4-BE49-F238E27FC236}">
                            <a16:creationId xmlns:a16="http://schemas.microsoft.com/office/drawing/2014/main" id="{A3478F6C-382D-E03C-CFA4-92ED208423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48868" y="1704975"/>
                        <a:ext cx="3590925" cy="172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282086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1CCD5C-4BD7-432C-85EC-6A097DD52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73079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Table 2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6E5F2300-2BFF-4A03-8D89-98E7A9670304}"/>
              </a:ext>
            </a:extLst>
          </p:cNvPr>
          <p:cNvSpPr txBox="1"/>
          <p:nvPr/>
        </p:nvSpPr>
        <p:spPr>
          <a:xfrm>
            <a:off x="62073" y="1226725"/>
            <a:ext cx="1991760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2a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vent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xclud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Univariate Analysis Overall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hor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bbrevi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MI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CV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C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T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otyp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Bc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r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HBs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rfa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defini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bas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on 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osit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/total score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corporat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resen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f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-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lic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e.g.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ascite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)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nfirma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rough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histolog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ultrasoun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live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stiffne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measuremen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LSM) vi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FibroSca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® (&gt;12.5 kPa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AST/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latele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rati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APRI &gt;2.0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FIB-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&gt;3.25).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5D078CAE-8078-4C97-B14A-518EE3F85FF6}"/>
              </a:ext>
            </a:extLst>
          </p:cNvPr>
          <p:cNvSpPr txBox="1"/>
          <p:nvPr/>
        </p:nvSpPr>
        <p:spPr>
          <a:xfrm>
            <a:off x="7727634" y="1098650"/>
            <a:ext cx="41749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2b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vent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xclud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– Multivariate Analysis Overall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hor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</p:txBody>
      </p:sp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126EEEF7-9CE9-FB05-AF21-B4D2B6B14C8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15905" y="811287"/>
          <a:ext cx="5334000" cy="572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5334080" imgH="5724353" progId="Excel.Sheet.12">
                  <p:embed/>
                </p:oleObj>
              </mc:Choice>
              <mc:Fallback>
                <p:oleObj name="Worksheet" r:id="rId2" imgW="5334080" imgH="5724353" progId="Excel.Sheet.12">
                  <p:embed/>
                  <p:pic>
                    <p:nvPicPr>
                      <p:cNvPr id="6" name="Objekt 5">
                        <a:extLst>
                          <a:ext uri="{FF2B5EF4-FFF2-40B4-BE49-F238E27FC236}">
                            <a16:creationId xmlns:a16="http://schemas.microsoft.com/office/drawing/2014/main" id="{126EEEF7-9CE9-FB05-AF21-B4D2B6B14C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15905" y="811287"/>
                        <a:ext cx="5334000" cy="5724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CC048253-A2E9-43E1-B420-9E824977937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727634" y="1791148"/>
          <a:ext cx="3619500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4" imgW="3619580" imgH="1723889" progId="Excel.Sheet.12">
                  <p:embed/>
                </p:oleObj>
              </mc:Choice>
              <mc:Fallback>
                <p:oleObj name="Worksheet" r:id="rId4" imgW="3619580" imgH="1723889" progId="Excel.Sheet.12">
                  <p:embed/>
                  <p:pic>
                    <p:nvPicPr>
                      <p:cNvPr id="7" name="Objekt 6">
                        <a:extLst>
                          <a:ext uri="{FF2B5EF4-FFF2-40B4-BE49-F238E27FC236}">
                            <a16:creationId xmlns:a16="http://schemas.microsoft.com/office/drawing/2014/main" id="{CC048253-A2E9-43E1-B420-9E82497793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27634" y="1791148"/>
                        <a:ext cx="3619500" cy="172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56779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1CCD5C-4BD7-432C-85EC-6A097DD52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73079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Table 3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6E5F2300-2BFF-4A03-8D89-98E7A9670304}"/>
              </a:ext>
            </a:extLst>
          </p:cNvPr>
          <p:cNvSpPr txBox="1"/>
          <p:nvPr/>
        </p:nvSpPr>
        <p:spPr>
          <a:xfrm>
            <a:off x="28426" y="1478546"/>
            <a:ext cx="1950199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3a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Univariate Analysis Overall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hor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bbrevi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MI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CV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C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T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otyp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Bc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r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HBs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rfa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defini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bas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on 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osit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/total score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corporat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resen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f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-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lic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e.g.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ascite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)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nfirma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rough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histolog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ultrasoun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live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stiffne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measuremen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LSM) vi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FibroSca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® (&gt;12.5 kPa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AST/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latele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rati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APRI &gt;2.0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FIB-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&gt;3.25).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5D078CAE-8078-4C97-B14A-518EE3F85FF6}"/>
              </a:ext>
            </a:extLst>
          </p:cNvPr>
          <p:cNvSpPr txBox="1"/>
          <p:nvPr/>
        </p:nvSpPr>
        <p:spPr>
          <a:xfrm>
            <a:off x="7768604" y="1147897"/>
            <a:ext cx="4174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3b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– Multivariate Analysis Overall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hor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</p:txBody>
      </p:sp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55D58C46-7B1D-C8C0-3C44-09A492A235B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87552" y="970775"/>
          <a:ext cx="5572125" cy="572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5572305" imgH="5724353" progId="Excel.Sheet.12">
                  <p:embed/>
                </p:oleObj>
              </mc:Choice>
              <mc:Fallback>
                <p:oleObj name="Worksheet" r:id="rId2" imgW="5572305" imgH="5724353" progId="Excel.Sheet.12">
                  <p:embed/>
                  <p:pic>
                    <p:nvPicPr>
                      <p:cNvPr id="7" name="Objekt 6">
                        <a:extLst>
                          <a:ext uri="{FF2B5EF4-FFF2-40B4-BE49-F238E27FC236}">
                            <a16:creationId xmlns:a16="http://schemas.microsoft.com/office/drawing/2014/main" id="{55D58C46-7B1D-C8C0-3C44-09A492A235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87552" y="970775"/>
                        <a:ext cx="5572125" cy="5724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>
            <a:extLst>
              <a:ext uri="{FF2B5EF4-FFF2-40B4-BE49-F238E27FC236}">
                <a16:creationId xmlns:a16="http://schemas.microsoft.com/office/drawing/2014/main" id="{C199E5E7-1AAD-419C-03A2-EDE44C297C9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768604" y="1704975"/>
          <a:ext cx="3752850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4" imgW="3752770" imgH="1723889" progId="Excel.Sheet.12">
                  <p:embed/>
                </p:oleObj>
              </mc:Choice>
              <mc:Fallback>
                <p:oleObj name="Worksheet" r:id="rId4" imgW="3752770" imgH="1723889" progId="Excel.Sheet.12">
                  <p:embed/>
                  <p:pic>
                    <p:nvPicPr>
                      <p:cNvPr id="10" name="Objekt 9">
                        <a:extLst>
                          <a:ext uri="{FF2B5EF4-FFF2-40B4-BE49-F238E27FC236}">
                            <a16:creationId xmlns:a16="http://schemas.microsoft.com/office/drawing/2014/main" id="{C199E5E7-1AAD-419C-03A2-EDE44C297C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68604" y="1704975"/>
                        <a:ext cx="3752850" cy="172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947893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1CCD5C-4BD7-432C-85EC-6A097DD52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73079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Table 4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6E5F2300-2BFF-4A03-8D89-98E7A9670304}"/>
              </a:ext>
            </a:extLst>
          </p:cNvPr>
          <p:cNvSpPr txBox="1"/>
          <p:nvPr/>
        </p:nvSpPr>
        <p:spPr>
          <a:xfrm>
            <a:off x="187735" y="1368460"/>
            <a:ext cx="2002393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4a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vent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clud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Univariate Analysis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bgroup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bbrevi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MI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CV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C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T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otyp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Bc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r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HBs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rfa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defini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bas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on 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osit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/total score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corporat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resen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f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-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lic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e.g.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ascite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)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nfirma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rough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histolog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ultrasoun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live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stiffne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measuremen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LSM) vi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FibroSca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® (&gt;12.5 kPa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AST/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latele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rati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APRI &gt;2.0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FIB-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&gt;3.25).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5D078CAE-8078-4C97-B14A-518EE3F85FF6}"/>
              </a:ext>
            </a:extLst>
          </p:cNvPr>
          <p:cNvSpPr txBox="1"/>
          <p:nvPr/>
        </p:nvSpPr>
        <p:spPr>
          <a:xfrm>
            <a:off x="7676415" y="1197458"/>
            <a:ext cx="41749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4b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vent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clud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– Multivariate Analysis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bgroup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9" name="Objekt 8">
            <a:extLst>
              <a:ext uri="{FF2B5EF4-FFF2-40B4-BE49-F238E27FC236}">
                <a16:creationId xmlns:a16="http://schemas.microsoft.com/office/drawing/2014/main" id="{083C938B-5D5A-BD84-AB27-01B74AAC02C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08568" y="847725"/>
          <a:ext cx="5162550" cy="5915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5162630" imgH="5915152" progId="Excel.Sheet.12">
                  <p:embed/>
                </p:oleObj>
              </mc:Choice>
              <mc:Fallback>
                <p:oleObj name="Worksheet" r:id="rId2" imgW="5162630" imgH="5915152" progId="Excel.Sheet.12">
                  <p:embed/>
                  <p:pic>
                    <p:nvPicPr>
                      <p:cNvPr id="9" name="Objekt 8">
                        <a:extLst>
                          <a:ext uri="{FF2B5EF4-FFF2-40B4-BE49-F238E27FC236}">
                            <a16:creationId xmlns:a16="http://schemas.microsoft.com/office/drawing/2014/main" id="{083C938B-5D5A-BD84-AB27-01B74AAC02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08568" y="847725"/>
                        <a:ext cx="5162550" cy="5915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id="{032BE1CF-9875-A5D6-74F8-24379E42202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707998" y="1895475"/>
          <a:ext cx="4143375" cy="153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4" imgW="4143315" imgH="1533462" progId="Excel.Sheet.12">
                  <p:embed/>
                </p:oleObj>
              </mc:Choice>
              <mc:Fallback>
                <p:oleObj name="Worksheet" r:id="rId4" imgW="4143315" imgH="1533462" progId="Excel.Sheet.12">
                  <p:embed/>
                  <p:pic>
                    <p:nvPicPr>
                      <p:cNvPr id="11" name="Objekt 10">
                        <a:extLst>
                          <a:ext uri="{FF2B5EF4-FFF2-40B4-BE49-F238E27FC236}">
                            <a16:creationId xmlns:a16="http://schemas.microsoft.com/office/drawing/2014/main" id="{032BE1CF-9875-A5D6-74F8-24379E4220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07998" y="1895475"/>
                        <a:ext cx="4143375" cy="153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269912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1CCD5C-4BD7-432C-85EC-6A097DD52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73079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Table 5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6E5F2300-2BFF-4A03-8D89-98E7A9670304}"/>
              </a:ext>
            </a:extLst>
          </p:cNvPr>
          <p:cNvSpPr txBox="1"/>
          <p:nvPr/>
        </p:nvSpPr>
        <p:spPr>
          <a:xfrm>
            <a:off x="98075" y="1306954"/>
            <a:ext cx="2087479" cy="47397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5a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vent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xclud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Univariate Analysis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bgroup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bbrevi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MI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CV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C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T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otyp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Bc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r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HBs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rfa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defini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bas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on 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osit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/total score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corporat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resen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f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-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lic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e.g.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ascite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)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nfirma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rough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histolog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ultrasoun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live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stiffne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measuremen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LSM) vi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FibroSca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® (&gt;12.5 kPa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AST/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latele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rati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APRI &gt;2.0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FIB-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&gt;3.25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.</a:t>
            </a:r>
            <a:endParaRPr kumimoji="0" lang="de-D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5D078CAE-8078-4C97-B14A-518EE3F85FF6}"/>
              </a:ext>
            </a:extLst>
          </p:cNvPr>
          <p:cNvSpPr txBox="1"/>
          <p:nvPr/>
        </p:nvSpPr>
        <p:spPr>
          <a:xfrm>
            <a:off x="7575587" y="1086834"/>
            <a:ext cx="41749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5b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vent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xclud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– Multivariate Analysis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bgroup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5B06313A-3E8D-D252-810B-B6B4D4825E8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85554" y="811287"/>
          <a:ext cx="5162550" cy="572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5162630" imgH="5724353" progId="Excel.Sheet.12">
                  <p:embed/>
                </p:oleObj>
              </mc:Choice>
              <mc:Fallback>
                <p:oleObj name="Worksheet" r:id="rId2" imgW="5162630" imgH="5724353" progId="Excel.Sheet.12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5B06313A-3E8D-D252-810B-B6B4D4825E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85554" y="811287"/>
                        <a:ext cx="5162550" cy="5724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36E8A1AD-46F4-12ED-6804-180A454DF4C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575587" y="1767515"/>
          <a:ext cx="4143375" cy="153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4" imgW="4143315" imgH="1533462" progId="Excel.Sheet.12">
                  <p:embed/>
                </p:oleObj>
              </mc:Choice>
              <mc:Fallback>
                <p:oleObj name="Worksheet" r:id="rId4" imgW="4143315" imgH="1533462" progId="Excel.Sheet.12">
                  <p:embed/>
                  <p:pic>
                    <p:nvPicPr>
                      <p:cNvPr id="4" name="Objekt 3">
                        <a:extLst>
                          <a:ext uri="{FF2B5EF4-FFF2-40B4-BE49-F238E27FC236}">
                            <a16:creationId xmlns:a16="http://schemas.microsoft.com/office/drawing/2014/main" id="{36E8A1AD-46F4-12ED-6804-180A454DF4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575587" y="1767515"/>
                        <a:ext cx="4143375" cy="153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175327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1CCD5C-4BD7-432C-85EC-6A097DD52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273079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Table 6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6E5F2300-2BFF-4A03-8D89-98E7A9670304}"/>
              </a:ext>
            </a:extLst>
          </p:cNvPr>
          <p:cNvSpPr txBox="1"/>
          <p:nvPr/>
        </p:nvSpPr>
        <p:spPr>
          <a:xfrm>
            <a:off x="182293" y="1350956"/>
            <a:ext cx="1950199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6a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– Univariate Analysis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bgroup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bbrevi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MI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a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CV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C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T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otyp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Bc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r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-HBs: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Hepatitis B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rfa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ge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;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defini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bas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on 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osit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/total score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corporating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resenc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f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irrhosis-relate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mplication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e.g.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ascite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)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confirmatio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rough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histolog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ultrasound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live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stiffnes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measuremen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LSM) via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FibroSca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® (&gt;12.5 kPa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AST/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latelet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rati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APRI &gt;2.0),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or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the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FIB-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index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 (&gt;3.25).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5D078CAE-8078-4C97-B14A-518EE3F85FF6}"/>
              </a:ext>
            </a:extLst>
          </p:cNvPr>
          <p:cNvSpPr txBox="1"/>
          <p:nvPr/>
        </p:nvSpPr>
        <p:spPr>
          <a:xfrm>
            <a:off x="7295042" y="1350956"/>
            <a:ext cx="4174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Table 6b: </a:t>
            </a:r>
            <a:b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</a:b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ovo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CC – Multivariate Analysis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rrhosis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bgroup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26BC7C14-3105-F1DE-5303-9B523BEAE7D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32492" y="843185"/>
          <a:ext cx="5162550" cy="572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5162630" imgH="5724353" progId="Excel.Sheet.12">
                  <p:embed/>
                </p:oleObj>
              </mc:Choice>
              <mc:Fallback>
                <p:oleObj name="Worksheet" r:id="rId2" imgW="5162630" imgH="5724353" progId="Excel.Sheet.12">
                  <p:embed/>
                  <p:pic>
                    <p:nvPicPr>
                      <p:cNvPr id="6" name="Objekt 5">
                        <a:extLst>
                          <a:ext uri="{FF2B5EF4-FFF2-40B4-BE49-F238E27FC236}">
                            <a16:creationId xmlns:a16="http://schemas.microsoft.com/office/drawing/2014/main" id="{26BC7C14-3105-F1DE-5303-9B523BEAE7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32492" y="843185"/>
                        <a:ext cx="5162550" cy="5724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>
            <a:extLst>
              <a:ext uri="{FF2B5EF4-FFF2-40B4-BE49-F238E27FC236}">
                <a16:creationId xmlns:a16="http://schemas.microsoft.com/office/drawing/2014/main" id="{E4BB56AC-04C7-1B6E-5F71-52C956A67D1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328047" y="1895475"/>
          <a:ext cx="4762500" cy="153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4" imgW="4762340" imgH="1533462" progId="Excel.Sheet.12">
                  <p:embed/>
                </p:oleObj>
              </mc:Choice>
              <mc:Fallback>
                <p:oleObj name="Worksheet" r:id="rId4" imgW="4762340" imgH="1533462" progId="Excel.Sheet.12">
                  <p:embed/>
                  <p:pic>
                    <p:nvPicPr>
                      <p:cNvPr id="9" name="Objekt 8">
                        <a:extLst>
                          <a:ext uri="{FF2B5EF4-FFF2-40B4-BE49-F238E27FC236}">
                            <a16:creationId xmlns:a16="http://schemas.microsoft.com/office/drawing/2014/main" id="{E4BB56AC-04C7-1B6E-5F71-52C956A67D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328047" y="1895475"/>
                        <a:ext cx="4762500" cy="153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2023751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7</Words>
  <Application>Microsoft Office PowerPoint</Application>
  <PresentationFormat>Breitbild</PresentationFormat>
  <Paragraphs>78</Paragraphs>
  <Slides>7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1_Office</vt:lpstr>
      <vt:lpstr>Worksheet</vt:lpstr>
      <vt:lpstr>Resolved HBV infection is not associated with liver-related outcomes after HCV cure – Data from the German Hepatitis C-Registry  </vt:lpstr>
      <vt:lpstr>Supplementary Table 1</vt:lpstr>
      <vt:lpstr>Supplementary Table 2</vt:lpstr>
      <vt:lpstr>Supplementary Table 3</vt:lpstr>
      <vt:lpstr>Supplementary Table 4</vt:lpstr>
      <vt:lpstr>Supplementary Table 5</vt:lpstr>
      <vt:lpstr>Supplementary Table 6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ilhelm, Laura Muana Dr.</dc:creator>
  <cp:lastModifiedBy>Wilhelm, Laura Muana Dr.</cp:lastModifiedBy>
  <cp:revision>5</cp:revision>
  <dcterms:created xsi:type="dcterms:W3CDTF">2026-02-13T16:34:02Z</dcterms:created>
  <dcterms:modified xsi:type="dcterms:W3CDTF">2026-02-13T17:01:01Z</dcterms:modified>
</cp:coreProperties>
</file>